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328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3672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575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4380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5030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4197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399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253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5714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644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2588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785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087D4-FEBB-47E5-AE73-8F75C2839FF9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0A638-585C-411C-A5BC-FC25160930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675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254712" y="1527776"/>
            <a:ext cx="4775631" cy="4157705"/>
            <a:chOff x="1254712" y="1527776"/>
            <a:chExt cx="4775631" cy="4157705"/>
          </a:xfrm>
        </p:grpSpPr>
        <p:sp>
          <p:nvSpPr>
            <p:cNvPr id="6" name="TextBox 5"/>
            <p:cNvSpPr txBox="1"/>
            <p:nvPr/>
          </p:nvSpPr>
          <p:spPr>
            <a:xfrm>
              <a:off x="1479574" y="1534936"/>
              <a:ext cx="4232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A.  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196422" y="1527776"/>
              <a:ext cx="413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B.  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1356817" y="2223351"/>
              <a:ext cx="6687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IL-6 (pg/ml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3019291" y="2229179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TNF-</a:t>
              </a:r>
              <a:r>
                <a:rPr lang="el-GR" sz="800" dirty="0"/>
                <a:t>α</a:t>
              </a:r>
              <a:r>
                <a:rPr lang="en-GB" sz="800" dirty="0"/>
                <a:t> (pg/ml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583481" y="2767232"/>
              <a:ext cx="22322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LPS                       -                        +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416318" y="2780731"/>
              <a:ext cx="22322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LPS                   -                        +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2054DA3A-677F-4958-A5E3-AF361DA127F9}"/>
                </a:ext>
              </a:extLst>
            </p:cNvPr>
            <p:cNvSpPr txBox="1"/>
            <p:nvPr/>
          </p:nvSpPr>
          <p:spPr>
            <a:xfrm>
              <a:off x="3591937" y="3291866"/>
              <a:ext cx="24384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I</a:t>
              </a:r>
              <a:r>
                <a:rPr lang="el-GR" sz="800" dirty="0"/>
                <a:t>κ</a:t>
              </a:r>
              <a:r>
                <a:rPr lang="en-GB" sz="800" dirty="0"/>
                <a:t>B</a:t>
              </a:r>
              <a:r>
                <a:rPr lang="el-GR" sz="800" dirty="0"/>
                <a:t>α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8CDF2B71-AE74-44D0-BF55-E4B7EF145998}"/>
                </a:ext>
              </a:extLst>
            </p:cNvPr>
            <p:cNvSpPr txBox="1"/>
            <p:nvPr/>
          </p:nvSpPr>
          <p:spPr>
            <a:xfrm>
              <a:off x="2696536" y="3733750"/>
              <a:ext cx="18820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LPS          -            +         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477204" y="3124445"/>
              <a:ext cx="4074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C.  </a:t>
              </a: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29171" y="3257100"/>
              <a:ext cx="808370" cy="54674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2054DA3A-677F-4958-A5E3-AF361DA127F9}"/>
                </a:ext>
              </a:extLst>
            </p:cNvPr>
            <p:cNvSpPr txBox="1"/>
            <p:nvPr/>
          </p:nvSpPr>
          <p:spPr>
            <a:xfrm>
              <a:off x="3591937" y="3516495"/>
              <a:ext cx="24101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800" dirty="0"/>
                <a:t>β-</a:t>
              </a:r>
              <a:r>
                <a:rPr lang="en-GB" sz="800" dirty="0"/>
                <a:t>actin</a:t>
              </a: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19588" y="1697951"/>
              <a:ext cx="3427999" cy="1180775"/>
            </a:xfrm>
            <a:prstGeom prst="rect">
              <a:avLst/>
            </a:prstGeom>
          </p:spPr>
        </p:pic>
        <p:cxnSp>
          <p:nvCxnSpPr>
            <p:cNvPr id="17" name="Straight Connector 16"/>
            <p:cNvCxnSpPr/>
            <p:nvPr/>
          </p:nvCxnSpPr>
          <p:spPr>
            <a:xfrm>
              <a:off x="2339275" y="1996686"/>
              <a:ext cx="59826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8CDF2B71-AE74-44D0-BF55-E4B7EF145998}"/>
                </a:ext>
              </a:extLst>
            </p:cNvPr>
            <p:cNvSpPr txBox="1"/>
            <p:nvPr/>
          </p:nvSpPr>
          <p:spPr>
            <a:xfrm>
              <a:off x="2498767" y="1846215"/>
              <a:ext cx="48588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 smtClean="0"/>
                <a:t>**</a:t>
              </a:r>
              <a:endParaRPr lang="en-GB" sz="700" b="1" dirty="0"/>
            </a:p>
          </p:txBody>
        </p:sp>
        <p:cxnSp>
          <p:nvCxnSpPr>
            <p:cNvPr id="21" name="Straight Connector 20"/>
            <p:cNvCxnSpPr/>
            <p:nvPr/>
          </p:nvCxnSpPr>
          <p:spPr>
            <a:xfrm>
              <a:off x="4086397" y="1996686"/>
              <a:ext cx="59826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8CDF2B71-AE74-44D0-BF55-E4B7EF145998}"/>
                </a:ext>
              </a:extLst>
            </p:cNvPr>
            <p:cNvSpPr txBox="1"/>
            <p:nvPr/>
          </p:nvSpPr>
          <p:spPr>
            <a:xfrm>
              <a:off x="4245889" y="1846215"/>
              <a:ext cx="48588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 smtClean="0"/>
                <a:t>**</a:t>
              </a:r>
              <a:endParaRPr lang="en-GB" sz="700" b="1" dirty="0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254712" y="4185070"/>
              <a:ext cx="4512761" cy="1500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050" b="1" dirty="0"/>
                <a:t>Figure 1S: Primary human monocytes are not primed to secrete IL-6 or TNF-α in the absence of LPS treatment. </a:t>
              </a:r>
              <a:r>
                <a:rPr lang="en-GB" sz="1050" dirty="0"/>
                <a:t>Freshly isolated human CD14</a:t>
              </a:r>
              <a:r>
                <a:rPr lang="en-GB" sz="1050" baseline="30000" dirty="0"/>
                <a:t>+ </a:t>
              </a:r>
              <a:r>
                <a:rPr lang="en-GB" sz="1050" dirty="0"/>
                <a:t>monocytes were left untreated or primed with LPS (1 µg/mL, 4h). (A) Cell supernatants were assayed for the release of IL-6. (B) Cell supernatants were assayed for the release of TNF-α. * = P &lt; 0.05; **** =P &lt;0.0001, n=3. (C) Western blot analysis of human monocyte lysates for IκBα (39 kDa) and loading control β-actin (42 kDa). Blots are representative of at least 3 independent experiments.</a:t>
              </a:r>
            </a:p>
            <a:p>
              <a:pPr algn="just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741582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46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loria Lopez-castejon</dc:creator>
  <cp:lastModifiedBy>Gloria Lopez-castejon</cp:lastModifiedBy>
  <cp:revision>4</cp:revision>
  <dcterms:created xsi:type="dcterms:W3CDTF">2020-01-29T16:50:14Z</dcterms:created>
  <dcterms:modified xsi:type="dcterms:W3CDTF">2020-01-30T09:56:11Z</dcterms:modified>
</cp:coreProperties>
</file>